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73" d="100"/>
          <a:sy n="73" d="100"/>
        </p:scale>
        <p:origin x="618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4A08D-A702-4928-B139-07D86509DCEA}" type="datetimeFigureOut">
              <a:rPr lang="en-GB" smtClean="0"/>
              <a:t>12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DA1B-E12D-4F6A-84AE-8BC447A71D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312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4A08D-A702-4928-B139-07D86509DCEA}" type="datetimeFigureOut">
              <a:rPr lang="en-GB" smtClean="0"/>
              <a:t>12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DA1B-E12D-4F6A-84AE-8BC447A71D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10686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4A08D-A702-4928-B139-07D86509DCEA}" type="datetimeFigureOut">
              <a:rPr lang="en-GB" smtClean="0"/>
              <a:t>12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DA1B-E12D-4F6A-84AE-8BC447A71D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43913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4A08D-A702-4928-B139-07D86509DCEA}" type="datetimeFigureOut">
              <a:rPr lang="en-GB" smtClean="0"/>
              <a:t>12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DA1B-E12D-4F6A-84AE-8BC447A71D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22095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4A08D-A702-4928-B139-07D86509DCEA}" type="datetimeFigureOut">
              <a:rPr lang="en-GB" smtClean="0"/>
              <a:t>12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DA1B-E12D-4F6A-84AE-8BC447A71D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38659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4A08D-A702-4928-B139-07D86509DCEA}" type="datetimeFigureOut">
              <a:rPr lang="en-GB" smtClean="0"/>
              <a:t>12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DA1B-E12D-4F6A-84AE-8BC447A71D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02300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4A08D-A702-4928-B139-07D86509DCEA}" type="datetimeFigureOut">
              <a:rPr lang="en-GB" smtClean="0"/>
              <a:t>12/04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DA1B-E12D-4F6A-84AE-8BC447A71D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24078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4A08D-A702-4928-B139-07D86509DCEA}" type="datetimeFigureOut">
              <a:rPr lang="en-GB" smtClean="0"/>
              <a:t>12/04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DA1B-E12D-4F6A-84AE-8BC447A71D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25405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4A08D-A702-4928-B139-07D86509DCEA}" type="datetimeFigureOut">
              <a:rPr lang="en-GB" smtClean="0"/>
              <a:t>12/04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DA1B-E12D-4F6A-84AE-8BC447A71D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73674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4A08D-A702-4928-B139-07D86509DCEA}" type="datetimeFigureOut">
              <a:rPr lang="en-GB" smtClean="0"/>
              <a:t>12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DA1B-E12D-4F6A-84AE-8BC447A71D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43947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4A08D-A702-4928-B139-07D86509DCEA}" type="datetimeFigureOut">
              <a:rPr lang="en-GB" smtClean="0"/>
              <a:t>12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DA1B-E12D-4F6A-84AE-8BC447A71D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06381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64A08D-A702-4928-B139-07D86509DCEA}" type="datetimeFigureOut">
              <a:rPr lang="en-GB" smtClean="0"/>
              <a:t>12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F0DA1B-E12D-4F6A-84AE-8BC447A71D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83293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899954" y="757641"/>
            <a:ext cx="2076994" cy="10772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aricella zoster </a:t>
            </a:r>
            <a:r>
              <a:rPr lang="en-U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roprevalence</a:t>
            </a:r>
            <a:endParaRPr lang="en-US" sz="16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11-2015</a:t>
            </a:r>
          </a:p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n=3139)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899954" y="2134276"/>
            <a:ext cx="2076994" cy="304698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fants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rom Vientiane Capital, </a:t>
            </a:r>
            <a:r>
              <a:rPr lang="en-U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uang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abang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sz="1600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-schoolers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rom </a:t>
            </a:r>
            <a:r>
              <a:rPr lang="en-U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ouaphan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sz="16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hool students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 Vientiane Capital, </a:t>
            </a:r>
            <a:r>
              <a:rPr lang="en-U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lhikamxay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uang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abang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vannakhet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sz="16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gnant women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 Vientiane Capital, </a:t>
            </a:r>
            <a:r>
              <a:rPr lang="en-U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uang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abang</a:t>
            </a:r>
            <a:endParaRPr lang="en-US" sz="16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ge 0 to 46 years)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894743" y="5669651"/>
            <a:ext cx="2076994" cy="86177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ra </a:t>
            </a:r>
          </a:p>
          <a:p>
            <a:pPr algn="ctr"/>
            <a:endParaRPr lang="en-US" sz="16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ZV IgG ELISA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25495" y="757645"/>
            <a:ext cx="2076994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ver-rash outbreak </a:t>
            </a:r>
          </a:p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15</a:t>
            </a:r>
          </a:p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n=42)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25495" y="2225718"/>
            <a:ext cx="2076994" cy="10772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ildren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6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ults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rom </a:t>
            </a:r>
            <a:r>
              <a:rPr lang="en-U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uang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abang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rovince</a:t>
            </a:r>
          </a:p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0 to 30 years) 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25495" y="3696318"/>
            <a:ext cx="2076994" cy="10772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ra, throat swabs </a:t>
            </a:r>
          </a:p>
          <a:p>
            <a:pPr algn="ctr"/>
            <a:endParaRPr lang="en-GB" sz="16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ZV; IgM ELISA, PCR, sequencing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372436" y="752297"/>
            <a:ext cx="3000920" cy="10772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ver-rash surveillance in children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15 </a:t>
            </a:r>
          </a:p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n=511)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372436" y="2225718"/>
            <a:ext cx="3000920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ildren Hospital OPD</a:t>
            </a:r>
          </a:p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ge 0 to 15 years)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372435" y="3139795"/>
            <a:ext cx="3000921" cy="304698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ra, throat swab, oral fluid </a:t>
            </a:r>
          </a:p>
          <a:p>
            <a:pPr algn="ctr"/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M ELISA; measle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ubella, parvovirus B19, adenovirus and VZV </a:t>
            </a:r>
            <a:endParaRPr lang="en-US" sz="16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en-US" sz="16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CR; parvovirus B19, HHV 6, 7, measles, enterovirus, VZV, rubella</a:t>
            </a:r>
          </a:p>
          <a:p>
            <a:pPr algn="ctr"/>
            <a:endParaRPr lang="en-US" sz="16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ing; measles, rubella, parvovirus B19 and VZV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8768845" y="757645"/>
            <a:ext cx="3000920" cy="86177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ver-rash etiology in suspected dengue cases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12/13 </a:t>
            </a:r>
          </a:p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n=108)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8768845" y="2225717"/>
            <a:ext cx="3000920" cy="584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entiane </a:t>
            </a:r>
            <a:r>
              <a:rPr lang="en-US" sz="16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pital </a:t>
            </a:r>
          </a:p>
          <a:p>
            <a:pPr algn="ctr"/>
            <a:r>
              <a:rPr lang="en-US" sz="16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e 0 to 60 years)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8768843" y="3139791"/>
            <a:ext cx="3000921" cy="10772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sma </a:t>
            </a:r>
          </a:p>
          <a:p>
            <a:pPr algn="ctr"/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M ELISA; measles, rubella, VZV and parvovirus B19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" name="Straight Arrow Connector 2"/>
          <p:cNvCxnSpPr>
            <a:stCxn id="8" idx="2"/>
            <a:endCxn id="9" idx="0"/>
          </p:cNvCxnSpPr>
          <p:nvPr/>
        </p:nvCxnSpPr>
        <p:spPr>
          <a:xfrm>
            <a:off x="1463992" y="1588642"/>
            <a:ext cx="0" cy="63707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>
            <a:stCxn id="9" idx="2"/>
          </p:cNvCxnSpPr>
          <p:nvPr/>
        </p:nvCxnSpPr>
        <p:spPr>
          <a:xfrm>
            <a:off x="1463992" y="3302936"/>
            <a:ext cx="952" cy="39085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3961174" y="1853470"/>
            <a:ext cx="0" cy="26774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 flipH="1">
            <a:off x="3933240" y="5194326"/>
            <a:ext cx="5212" cy="42270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>
            <a:off x="6872895" y="1957974"/>
            <a:ext cx="0" cy="26774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>
            <a:off x="6872895" y="2845921"/>
            <a:ext cx="0" cy="26774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>
            <a:stCxn id="14" idx="2"/>
          </p:cNvCxnSpPr>
          <p:nvPr/>
        </p:nvCxnSpPr>
        <p:spPr>
          <a:xfrm flipH="1">
            <a:off x="10269303" y="1619419"/>
            <a:ext cx="2" cy="61646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>
            <a:off x="10269303" y="2865972"/>
            <a:ext cx="0" cy="26774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425495" y="143689"/>
            <a:ext cx="67051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Over-view of cohorts and methodology used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90517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4</TotalTime>
  <Words>190</Words>
  <Application>Microsoft Office PowerPoint</Application>
  <PresentationFormat>Widescreen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ony BLACK</dc:creator>
  <cp:lastModifiedBy>Antony BLACK</cp:lastModifiedBy>
  <cp:revision>15</cp:revision>
  <dcterms:created xsi:type="dcterms:W3CDTF">2018-10-24T08:05:41Z</dcterms:created>
  <dcterms:modified xsi:type="dcterms:W3CDTF">2019-04-12T07:20:15Z</dcterms:modified>
</cp:coreProperties>
</file>